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3" d="100"/>
          <a:sy n="83" d="100"/>
        </p:scale>
        <p:origin x="313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547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048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912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798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457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564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4932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548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31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023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2097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227C4A-84FE-4036-923A-C40AC79545E8}" type="datetimeFigureOut">
              <a:rPr lang="en-US" smtClean="0"/>
              <a:t>4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F69EF-5C00-44A4-87B0-D6E03E88CA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1138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EC96E134-9330-4D9D-9CFC-320663AC67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9008806"/>
              </p:ext>
            </p:extLst>
          </p:nvPr>
        </p:nvGraphicFramePr>
        <p:xfrm>
          <a:off x="867926" y="962762"/>
          <a:ext cx="6036548" cy="7252670"/>
        </p:xfrm>
        <a:graphic>
          <a:graphicData uri="http://schemas.openxmlformats.org/drawingml/2006/table">
            <a:tbl>
              <a:tblPr firstRow="1" bandRow="1">
                <a:tableStyleId>{5A111915-BE36-4E01-A7E5-04B1672EAD32}</a:tableStyleId>
              </a:tblPr>
              <a:tblGrid>
                <a:gridCol w="898924">
                  <a:extLst>
                    <a:ext uri="{9D8B030D-6E8A-4147-A177-3AD203B41FA5}">
                      <a16:colId xmlns:a16="http://schemas.microsoft.com/office/drawing/2014/main" val="562614945"/>
                    </a:ext>
                  </a:extLst>
                </a:gridCol>
                <a:gridCol w="1205233">
                  <a:extLst>
                    <a:ext uri="{9D8B030D-6E8A-4147-A177-3AD203B41FA5}">
                      <a16:colId xmlns:a16="http://schemas.microsoft.com/office/drawing/2014/main" val="3452413016"/>
                    </a:ext>
                  </a:extLst>
                </a:gridCol>
                <a:gridCol w="3932391">
                  <a:extLst>
                    <a:ext uri="{9D8B030D-6E8A-4147-A177-3AD203B41FA5}">
                      <a16:colId xmlns:a16="http://schemas.microsoft.com/office/drawing/2014/main" val="2356829938"/>
                    </a:ext>
                  </a:extLst>
                </a:gridCol>
              </a:tblGrid>
              <a:tr h="234327">
                <a:tc>
                  <a:txBody>
                    <a:bodyPr/>
                    <a:lstStyle/>
                    <a:p>
                      <a:r>
                        <a:rPr lang="en-US" sz="1400" dirty="0"/>
                        <a:t>Iron categor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/>
                        <a:t>Photographic examp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/>
                        <a:t>Description of liver (hepatopancreas) sections stained with Perl’s Prussian blue iron stai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0774410"/>
                  </a:ext>
                </a:extLst>
              </a:tr>
              <a:tr h="81778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7</a:t>
                      </a:r>
                    </a:p>
                    <a:p>
                      <a:pPr algn="ctr"/>
                      <a:endParaRPr lang="en-US" dirty="0">
                        <a:latin typeface="+mn-lt"/>
                      </a:endParaRPr>
                    </a:p>
                    <a:p>
                      <a:pPr algn="ctr"/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nly observed in fish from Lake Ngami, bright blue throughout liver, sometimes narrow light pink halos of hepatocytes around acinar bundles; melano-macrophage aggregates stained deep blue or deep blue with some brown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04085482"/>
                  </a:ext>
                </a:extLst>
              </a:tr>
              <a:tr h="810491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right blue throughout liver, but appearance is more stippled than score value “7”; narrow pale halos around acinar bundles; melano-macrophage aggregates are deep blue.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09809846"/>
                  </a:ext>
                </a:extLst>
              </a:tr>
              <a:tr h="845127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tippled bright blue with pale halos around acinar bundles; melano-macrophage aggregates are mixed brown and blue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761822355"/>
                  </a:ext>
                </a:extLst>
              </a:tr>
              <a:tr h="1737360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ither 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just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None/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) Stippled bright blue with pale halos around acinar bundles that are larger than blue stippled areas; melano-macrophage aggregates generally all brown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dirty="0">
                        <a:solidFill>
                          <a:srgbClr val="2A2D35"/>
                        </a:solidFill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r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just">
                        <a:spcBef>
                          <a:spcPts val="0"/>
                        </a:spcBef>
                        <a:spcAft>
                          <a:spcPts val="0"/>
                        </a:spcAft>
                        <a:buFont typeface="+mj-lt"/>
                        <a:buNone/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) Blue stippling in hepatocytes is pale and tends to blend with halos around acinar bundles; melano-macrophage aggregates are deep blue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98598884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ue stippling in hepatocytes is very pale and tends to blend with pale halos around acinar bundles or blue stippling appears on liver section edges only; melano-macrophage aggregates are brown, or blue and brown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903441603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ue stippling minor and present on section edges only; melano-macrophage aggregates mostly brown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92233557"/>
                  </a:ext>
                </a:extLst>
              </a:tr>
              <a:tr h="841248"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+mn-lt"/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  <a:p>
                      <a:endParaRPr lang="en-US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just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2A2D35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ue staining absent or covers less than 2% of total tissue area.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33568389"/>
                  </a:ext>
                </a:extLst>
              </a:tr>
            </a:tbl>
          </a:graphicData>
        </a:graphic>
      </p:graphicFrame>
      <p:grpSp>
        <p:nvGrpSpPr>
          <p:cNvPr id="2" name="Group 1">
            <a:extLst>
              <a:ext uri="{FF2B5EF4-FFF2-40B4-BE49-F238E27FC236}">
                <a16:creationId xmlns:a16="http://schemas.microsoft.com/office/drawing/2014/main" id="{E0C2F98F-5963-4959-9C9C-3EAC1E3A4F19}"/>
              </a:ext>
            </a:extLst>
          </p:cNvPr>
          <p:cNvGrpSpPr/>
          <p:nvPr/>
        </p:nvGrpSpPr>
        <p:grpSpPr>
          <a:xfrm>
            <a:off x="1806381" y="1494737"/>
            <a:ext cx="1054735" cy="6695262"/>
            <a:chOff x="1806381" y="1494737"/>
            <a:chExt cx="1054735" cy="6695262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BDFD2DE-517F-4C91-9E74-7CCFE9701BD6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6381" y="1494737"/>
              <a:ext cx="1054735" cy="79057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69C360F-EDEC-4BAA-A925-0622C7AB4CE0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6381" y="2308610"/>
              <a:ext cx="1051560" cy="78867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8A4C429A-1601-4709-9F61-CAA161D9D27B}"/>
                </a:ext>
              </a:extLst>
            </p:cNvPr>
            <p:cNvPicPr/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6381" y="3134433"/>
              <a:ext cx="1051560" cy="78867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76CA1DA-F972-41DE-A90F-652D789C2A65}"/>
                </a:ext>
              </a:extLst>
            </p:cNvPr>
            <p:cNvPicPr/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6381" y="3991427"/>
              <a:ext cx="1051560" cy="78867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6187F171-622D-4F98-A1E7-73073BBB8177}"/>
                </a:ext>
              </a:extLst>
            </p:cNvPr>
            <p:cNvPicPr/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6381" y="4871910"/>
              <a:ext cx="1051560" cy="78867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1B426F98-3419-465D-B057-C6C7FF5FD871}"/>
                </a:ext>
              </a:extLst>
            </p:cNvPr>
            <p:cNvPicPr/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6381" y="5708123"/>
              <a:ext cx="1051560" cy="78867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E630DE76-C3A7-49C6-A6E8-01229D379E21}"/>
                </a:ext>
              </a:extLst>
            </p:cNvPr>
            <p:cNvPicPr/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6381" y="6554726"/>
              <a:ext cx="1051560" cy="78867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04D4B46D-6238-4BD9-81B9-40B883B6B19E}"/>
                </a:ext>
              </a:extLst>
            </p:cNvPr>
            <p:cNvPicPr/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06381" y="7401329"/>
              <a:ext cx="1051560" cy="78867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2855178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</TotalTime>
  <Words>225</Words>
  <Application>Microsoft Office PowerPoint</Application>
  <PresentationFormat>Custom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s, Thea M</dc:creator>
  <cp:lastModifiedBy>Edwards, Thea M</cp:lastModifiedBy>
  <cp:revision>12</cp:revision>
  <dcterms:created xsi:type="dcterms:W3CDTF">2020-04-08T20:48:34Z</dcterms:created>
  <dcterms:modified xsi:type="dcterms:W3CDTF">2020-04-09T13:56:58Z</dcterms:modified>
</cp:coreProperties>
</file>